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7" d="100"/>
          <a:sy n="107" d="100"/>
        </p:scale>
        <p:origin x="662" y="5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259877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70493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093765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5815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957475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76068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957344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733957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987128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4772053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H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220942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H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2DDAB-7DD1-4C8A-9CE3-A4407E4AC9BC}" type="datetimeFigureOut">
              <a:rPr lang="fr-CH" smtClean="0"/>
              <a:t>02.01.2022</a:t>
            </a:fld>
            <a:endParaRPr lang="fr-CH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35961-7679-4326-850E-C0CE2E2312DB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745923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e 10"/>
          <p:cNvGrpSpPr/>
          <p:nvPr/>
        </p:nvGrpSpPr>
        <p:grpSpPr>
          <a:xfrm>
            <a:off x="597928" y="67433"/>
            <a:ext cx="4521255" cy="3340839"/>
            <a:chOff x="597928" y="286638"/>
            <a:chExt cx="4521255" cy="3340839"/>
          </a:xfrm>
        </p:grpSpPr>
        <p:grpSp>
          <p:nvGrpSpPr>
            <p:cNvPr id="9" name="Groupe 8"/>
            <p:cNvGrpSpPr/>
            <p:nvPr/>
          </p:nvGrpSpPr>
          <p:grpSpPr>
            <a:xfrm>
              <a:off x="839244" y="525165"/>
              <a:ext cx="4279939" cy="3102312"/>
              <a:chOff x="1516136" y="70010"/>
              <a:chExt cx="5932763" cy="4398764"/>
            </a:xfrm>
          </p:grpSpPr>
          <p:sp>
            <p:nvSpPr>
              <p:cNvPr id="6" name="ZoneTexte 5"/>
              <p:cNvSpPr txBox="1"/>
              <p:nvPr/>
            </p:nvSpPr>
            <p:spPr>
              <a:xfrm>
                <a:off x="1826668" y="70010"/>
                <a:ext cx="5622231" cy="3709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. </a:t>
                </a:r>
                <a:r>
                  <a:rPr lang="fr-CH" sz="11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fr-CH" sz="11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bicans</a:t>
                </a:r>
                <a:r>
                  <a:rPr lang="fr-CH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O vs MNV </a:t>
                </a:r>
                <a:r>
                  <a:rPr lang="fr-CH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reakpoint-based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CH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ategories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 n = 88)</a:t>
                </a:r>
                <a:endParaRPr lang="fr-CH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ZoneTexte 6"/>
              <p:cNvSpPr txBox="1"/>
              <p:nvPr/>
            </p:nvSpPr>
            <p:spPr>
              <a:xfrm rot="16200000">
                <a:off x="1391583" y="2282154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NV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3482236" y="4191775"/>
                <a:ext cx="4074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O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" name="ZoneTexte 9"/>
            <p:cNvSpPr txBox="1"/>
            <p:nvPr/>
          </p:nvSpPr>
          <p:spPr>
            <a:xfrm>
              <a:off x="597928" y="286638"/>
              <a:ext cx="4411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dirty="0" smtClean="0"/>
                <a:t>A- </a:t>
              </a:r>
              <a:endParaRPr lang="fr-CH" dirty="0"/>
            </a:p>
          </p:txBody>
        </p:sp>
      </p:grpSp>
      <p:sp>
        <p:nvSpPr>
          <p:cNvPr id="18" name="ZoneTexte 17"/>
          <p:cNvSpPr txBox="1"/>
          <p:nvPr/>
        </p:nvSpPr>
        <p:spPr>
          <a:xfrm rot="16200000">
            <a:off x="6329806" y="1863881"/>
            <a:ext cx="371046" cy="199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NV</a:t>
            </a:r>
            <a:endParaRPr lang="fr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7833773" y="321291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N</a:t>
            </a:r>
            <a:endParaRPr lang="fr-CH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6174098" y="67433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dirty="0"/>
              <a:t>C</a:t>
            </a:r>
            <a:r>
              <a:rPr lang="fr-CH" dirty="0" smtClean="0"/>
              <a:t>- </a:t>
            </a:r>
            <a:endParaRPr lang="fr-CH" dirty="0"/>
          </a:p>
        </p:txBody>
      </p:sp>
      <p:grpSp>
        <p:nvGrpSpPr>
          <p:cNvPr id="20" name="Groupe 19"/>
          <p:cNvGrpSpPr/>
          <p:nvPr/>
        </p:nvGrpSpPr>
        <p:grpSpPr>
          <a:xfrm>
            <a:off x="597928" y="3450828"/>
            <a:ext cx="4763150" cy="3340839"/>
            <a:chOff x="597928" y="286638"/>
            <a:chExt cx="4763150" cy="3340839"/>
          </a:xfrm>
        </p:grpSpPr>
        <p:grpSp>
          <p:nvGrpSpPr>
            <p:cNvPr id="21" name="Groupe 20"/>
            <p:cNvGrpSpPr/>
            <p:nvPr/>
          </p:nvGrpSpPr>
          <p:grpSpPr>
            <a:xfrm>
              <a:off x="839244" y="493849"/>
              <a:ext cx="4521834" cy="3133628"/>
              <a:chOff x="1516136" y="25608"/>
              <a:chExt cx="6268069" cy="4443166"/>
            </a:xfrm>
          </p:grpSpPr>
          <p:sp>
            <p:nvSpPr>
              <p:cNvPr id="25" name="ZoneTexte 24"/>
              <p:cNvSpPr txBox="1"/>
              <p:nvPr/>
            </p:nvSpPr>
            <p:spPr>
              <a:xfrm>
                <a:off x="1919776" y="25608"/>
                <a:ext cx="5864429" cy="3709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. </a:t>
                </a:r>
                <a:r>
                  <a:rPr lang="fr-CH" sz="11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fr-CH" sz="11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lbicans</a:t>
                </a:r>
                <a:r>
                  <a:rPr lang="fr-CH" sz="1100" i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O vs MNV ECV/ECOFF-</a:t>
                </a:r>
                <a:r>
                  <a:rPr lang="fr-CH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ased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fr-CH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ategories</a:t>
                </a:r>
                <a:r>
                  <a:rPr lang="fr-CH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n = 110)</a:t>
                </a:r>
                <a:endParaRPr lang="fr-CH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" name="ZoneTexte 25"/>
              <p:cNvSpPr txBox="1"/>
              <p:nvPr/>
            </p:nvSpPr>
            <p:spPr>
              <a:xfrm rot="16200000">
                <a:off x="1391583" y="2282154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NV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>
                <a:off x="3482236" y="4191775"/>
                <a:ext cx="4074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YO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ZoneTexte 21"/>
            <p:cNvSpPr txBox="1"/>
            <p:nvPr/>
          </p:nvSpPr>
          <p:spPr>
            <a:xfrm>
              <a:off x="597928" y="286638"/>
              <a:ext cx="4331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dirty="0"/>
                <a:t>B</a:t>
              </a:r>
              <a:r>
                <a:rPr lang="fr-CH" dirty="0" smtClean="0"/>
                <a:t>- </a:t>
              </a:r>
              <a:endParaRPr lang="fr-CH" dirty="0"/>
            </a:p>
          </p:txBody>
        </p:sp>
      </p:grpSp>
      <p:grpSp>
        <p:nvGrpSpPr>
          <p:cNvPr id="28" name="Groupe 27"/>
          <p:cNvGrpSpPr/>
          <p:nvPr/>
        </p:nvGrpSpPr>
        <p:grpSpPr>
          <a:xfrm>
            <a:off x="6174098" y="3450828"/>
            <a:ext cx="2083189" cy="3422479"/>
            <a:chOff x="597928" y="286638"/>
            <a:chExt cx="2083189" cy="3422479"/>
          </a:xfrm>
        </p:grpSpPr>
        <p:grpSp>
          <p:nvGrpSpPr>
            <p:cNvPr id="29" name="Groupe 28"/>
            <p:cNvGrpSpPr/>
            <p:nvPr/>
          </p:nvGrpSpPr>
          <p:grpSpPr>
            <a:xfrm>
              <a:off x="839244" y="1997478"/>
              <a:ext cx="1841873" cy="1711639"/>
              <a:chOff x="1516136" y="2157601"/>
              <a:chExt cx="2553166" cy="2426930"/>
            </a:xfrm>
          </p:grpSpPr>
          <p:sp>
            <p:nvSpPr>
              <p:cNvPr id="34" name="ZoneTexte 33"/>
              <p:cNvSpPr txBox="1"/>
              <p:nvPr/>
            </p:nvSpPr>
            <p:spPr>
              <a:xfrm rot="16200000">
                <a:off x="1391583" y="2282154"/>
                <a:ext cx="5261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NV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3482236" y="4191775"/>
                <a:ext cx="587066" cy="3927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CH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N</a:t>
                </a:r>
                <a:endParaRPr lang="fr-CH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0" name="ZoneTexte 29"/>
            <p:cNvSpPr txBox="1"/>
            <p:nvPr/>
          </p:nvSpPr>
          <p:spPr>
            <a:xfrm>
              <a:off x="597928" y="286638"/>
              <a:ext cx="450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H" dirty="0" smtClean="0"/>
                <a:t>D- </a:t>
              </a:r>
              <a:endParaRPr lang="fr-CH" dirty="0"/>
            </a:p>
          </p:txBody>
        </p:sp>
      </p:grpSp>
      <p:sp>
        <p:nvSpPr>
          <p:cNvPr id="44" name="ZoneTexte 43"/>
          <p:cNvSpPr txBox="1"/>
          <p:nvPr/>
        </p:nvSpPr>
        <p:spPr>
          <a:xfrm>
            <a:off x="4609056" y="1562828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= 23 (26.1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4609056" y="1720970"/>
            <a:ext cx="9220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33 (37.5%)  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4605652" y="1879112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30 (34.1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4609056" y="2037254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2 (2.2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4611129" y="2195395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110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4605374" y="4928329"/>
            <a:ext cx="7777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76 (69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ZoneTexte 49"/>
          <p:cNvSpPr txBox="1"/>
          <p:nvPr/>
        </p:nvSpPr>
        <p:spPr>
          <a:xfrm>
            <a:off x="4605374" y="5090026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29 (26.4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ZoneTexte 50"/>
          <p:cNvSpPr txBox="1"/>
          <p:nvPr/>
        </p:nvSpPr>
        <p:spPr>
          <a:xfrm>
            <a:off x="4605374" y="5251723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3 (27.3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605374" y="5413420"/>
            <a:ext cx="8354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4 (3.6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ZoneTexte 52"/>
          <p:cNvSpPr txBox="1"/>
          <p:nvPr/>
        </p:nvSpPr>
        <p:spPr>
          <a:xfrm>
            <a:off x="4605374" y="5575116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88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Image 6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3" t="4531" r="40964" b="37227"/>
          <a:stretch/>
        </p:blipFill>
        <p:spPr>
          <a:xfrm>
            <a:off x="1063264" y="726941"/>
            <a:ext cx="3621416" cy="2485973"/>
          </a:xfrm>
          <a:prstGeom prst="rect">
            <a:avLst/>
          </a:prstGeom>
        </p:spPr>
      </p:pic>
      <p:pic>
        <p:nvPicPr>
          <p:cNvPr id="66" name="Image 6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3" t="4649" r="40886" b="36992"/>
          <a:stretch/>
        </p:blipFill>
        <p:spPr>
          <a:xfrm>
            <a:off x="1084864" y="4169416"/>
            <a:ext cx="3601421" cy="2473804"/>
          </a:xfrm>
          <a:prstGeom prst="rect">
            <a:avLst/>
          </a:prstGeom>
        </p:spPr>
      </p:pic>
      <p:sp>
        <p:nvSpPr>
          <p:cNvPr id="69" name="ZoneTexte 68"/>
          <p:cNvSpPr txBox="1"/>
          <p:nvPr/>
        </p:nvSpPr>
        <p:spPr>
          <a:xfrm>
            <a:off x="6716235" y="300717"/>
            <a:ext cx="40607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fr-CH" sz="1100" i="1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fr-CH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rata</a:t>
            </a:r>
            <a:r>
              <a:rPr lang="fr-CH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YO vs MNV </a:t>
            </a:r>
            <a:r>
              <a:rPr lang="fr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reakpoint-based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gories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 n = 54)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ZoneTexte 69"/>
          <p:cNvSpPr txBox="1"/>
          <p:nvPr/>
        </p:nvSpPr>
        <p:spPr>
          <a:xfrm>
            <a:off x="6716235" y="3663436"/>
            <a:ext cx="42210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fr-CH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labrata</a:t>
            </a:r>
            <a:r>
              <a:rPr lang="fr-CH" sz="11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YO vs MNV ECV/ECOFF-</a:t>
            </a:r>
            <a:r>
              <a:rPr lang="fr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CH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tegories</a:t>
            </a:r>
            <a:r>
              <a:rPr lang="fr-CH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n = 126)</a:t>
            </a:r>
            <a:endParaRPr lang="fr-CH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Image 7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" t="4766" r="41198" b="37110"/>
          <a:stretch/>
        </p:blipFill>
        <p:spPr>
          <a:xfrm>
            <a:off x="6623961" y="735850"/>
            <a:ext cx="3645391" cy="2507787"/>
          </a:xfrm>
          <a:prstGeom prst="rect">
            <a:avLst/>
          </a:prstGeom>
        </p:spPr>
      </p:pic>
      <p:sp>
        <p:nvSpPr>
          <p:cNvPr id="54" name="ZoneTexte 53"/>
          <p:cNvSpPr txBox="1"/>
          <p:nvPr/>
        </p:nvSpPr>
        <p:spPr>
          <a:xfrm>
            <a:off x="10125936" y="1561333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= 10 (18.5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ZoneTexte 54"/>
          <p:cNvSpPr txBox="1"/>
          <p:nvPr/>
        </p:nvSpPr>
        <p:spPr>
          <a:xfrm>
            <a:off x="10125936" y="1719475"/>
            <a:ext cx="8354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40 (74%)  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10122532" y="1877617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4 (7.5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ZoneTexte 56"/>
          <p:cNvSpPr txBox="1"/>
          <p:nvPr/>
        </p:nvSpPr>
        <p:spPr>
          <a:xfrm>
            <a:off x="10125936" y="2035759"/>
            <a:ext cx="72006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0 (0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10128009" y="2193900"/>
            <a:ext cx="53251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108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Image 7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4" t="4297" r="41276" b="36875"/>
          <a:stretch/>
        </p:blipFill>
        <p:spPr>
          <a:xfrm>
            <a:off x="6636541" y="4058864"/>
            <a:ext cx="3706647" cy="2584356"/>
          </a:xfrm>
          <a:prstGeom prst="rect">
            <a:avLst/>
          </a:prstGeom>
        </p:spPr>
      </p:pic>
      <p:sp>
        <p:nvSpPr>
          <p:cNvPr id="61" name="ZoneTexte 60"/>
          <p:cNvSpPr txBox="1"/>
          <p:nvPr/>
        </p:nvSpPr>
        <p:spPr>
          <a:xfrm>
            <a:off x="10142852" y="5242007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19 (15.1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10146256" y="4925723"/>
            <a:ext cx="8643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 = 51 (40.5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ZoneTexte 59"/>
          <p:cNvSpPr txBox="1"/>
          <p:nvPr/>
        </p:nvSpPr>
        <p:spPr>
          <a:xfrm>
            <a:off x="10146256" y="5083865"/>
            <a:ext cx="9220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54 (42.9%)  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10146256" y="5400149"/>
            <a:ext cx="8066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02 (1.5%)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10148329" y="5558290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H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n = 36</a:t>
            </a:r>
            <a:endParaRPr lang="fr-CH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9506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2</Words>
  <Application>Microsoft Office PowerPoint</Application>
  <PresentationFormat>Grand écran</PresentationFormat>
  <Paragraphs>3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oste Alix</dc:creator>
  <cp:lastModifiedBy>Coste Alix</cp:lastModifiedBy>
  <cp:revision>10</cp:revision>
  <dcterms:created xsi:type="dcterms:W3CDTF">2022-01-02T13:08:16Z</dcterms:created>
  <dcterms:modified xsi:type="dcterms:W3CDTF">2022-01-02T16:28:08Z</dcterms:modified>
</cp:coreProperties>
</file>